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4" r:id="rId3"/>
    <p:sldId id="272" r:id="rId4"/>
    <p:sldId id="266" r:id="rId5"/>
    <p:sldId id="27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B91CD7-747E-4727-C52D-0E99DF666C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AF2D28-3120-3EF0-8867-FC1C4BFC17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F85F43-3B74-BDB6-1C5C-C41D172D7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747A60-0827-1B51-89D1-4358BB3E8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659EE2-27EF-8DD8-EADB-082F4A3A7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261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B5718F-BC46-133C-A35B-AFA79D71D1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C77E8B-5E27-6259-8185-5D0A621228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31A0D5-89DE-1B4A-4CA3-42C5DB7D9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172C2A-27A0-365F-3DFB-A77EB0EA5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B7B260-78C6-40D2-8F18-CB7878146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494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F16B42-9B64-C826-70B7-ADBB3278A9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C1BD01-68DB-49AD-21F4-5C7EEFB12C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77E46F-A770-5209-9116-F9EBABE81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0593D-AE5D-9704-3B76-194DFFDCB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555353-78E2-4CC0-BD0E-14BDEE0E9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853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DB443F-9EED-F879-8C10-B3E2BAB170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33601B-CDA2-ED27-0BE8-9344BCEEC4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625D10-B3E5-0A92-1AA7-3369C27BF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B824B6-747E-1A63-0E96-BA11ECFD9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F2E02E-E076-DDEF-BE88-36EEFC1B6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7017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99BF2F-975C-CE1B-E13B-ED26898EC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6253F8-1970-0C0A-C504-0C1157E847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3373E-D7C9-5582-C385-2C4B60495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BB971A-B36D-3E22-FD8F-481EE063B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8B2E62-9663-9984-5AA0-9D2CE756C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788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9FFD7B-357C-865F-1057-9FA9F9C2A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090746-D284-FC8D-7348-47F929692B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00B780-F7A4-34A1-8785-1B55FF8111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2352CD-B181-172C-2933-AB8DBFE86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42D6F3-2F8A-307D-79B0-435814811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880CA0-05F8-1147-1F48-16869BBBF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174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FD2F89-4F82-AAB1-8D16-7775C739D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CB2D1E-FB88-7DFA-D5F7-53AF1CBA23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3EDD58-855D-286D-9CF6-285437D404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7C3A44-E985-C502-58B0-A8D8C9D90B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9BDC26-89BB-3C76-B2CC-FE52AF6741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6D5449-955F-B222-7F35-6821405BCB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387C73-55F1-B65D-4051-21C456C03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2A70B1E-DAD6-E2E1-E937-7ECCFAFBF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288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E2F6BE-CC7B-27CA-5408-E703038D75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612F0C0-FDCD-D54F-22D6-E85B2F8BE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0192C0-F2E8-41B1-27CD-EBA030A29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5F0441-1796-7C62-86FC-E032E990F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35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2A4127-4E3A-7469-7F9E-E59306EA7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CC9A41-3EDE-36BE-EAAF-995965B873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9E4C2F8-4ACE-FB68-0828-ED4CCCEF87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566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66B33C-13EB-F392-165B-D76DC4D2C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DE78AA-113A-54D2-BEC7-CF9D92059B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D96A9F-8E8C-9130-0E77-371B7E739C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F23386-3FFF-9CE9-CC49-C7543CBEB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7C9161-7A18-29D1-6B4C-7AFC14DD0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3E6267-7852-A0D8-B7A9-173385D6E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422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ABF9F-BA50-C2D4-E80B-DB3B41CB6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64B8F8-D65D-730A-7A89-63415CC8C1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2D28C9-640A-17A8-8B1F-92D7750974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9D8CCE-222F-ACBB-69B7-A3763BD8E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DEDF17-D547-AB04-4CE5-163320A3C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B1416B-9FEB-516A-3132-B1CB2A4FF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360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BBB904-0E16-A993-4821-75D5734A4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277909-33DC-E329-0DB8-747CDC665B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1EB8D3-2C7E-E7D0-8863-C4BCAE8980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E39B9D-C4F3-4280-95B9-FF90C72C8879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6002DE-60BD-52F1-5AE7-08B57757CE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EE938D-79AB-AC8C-F96E-ED78CC2086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7D50A7-DBB6-49FA-AF76-15E378EA9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506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4.emf"/><Relationship Id="rId4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5" Type="http://schemas.microsoft.com/office/2007/relationships/hdphoto" Target="../media/hdphoto1.wdp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A4F2DBD-9540-498A-A7BA-069BC288AB2C}"/>
              </a:ext>
            </a:extLst>
          </p:cNvPr>
          <p:cNvSpPr txBox="1"/>
          <p:nvPr/>
        </p:nvSpPr>
        <p:spPr>
          <a:xfrm>
            <a:off x="195943" y="139959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6EA1223-96C3-C8BD-DA92-1F95612C6427}"/>
              </a:ext>
            </a:extLst>
          </p:cNvPr>
          <p:cNvGraphicFramePr>
            <a:graphicFrameLocks noGrp="1"/>
          </p:cNvGraphicFramePr>
          <p:nvPr/>
        </p:nvGraphicFramePr>
        <p:xfrm>
          <a:off x="2996746" y="1592425"/>
          <a:ext cx="6389850" cy="158242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72741">
                  <a:extLst>
                    <a:ext uri="{9D8B030D-6E8A-4147-A177-3AD203B41FA5}">
                      <a16:colId xmlns:a16="http://schemas.microsoft.com/office/drawing/2014/main" val="1137209126"/>
                    </a:ext>
                  </a:extLst>
                </a:gridCol>
                <a:gridCol w="2460263">
                  <a:extLst>
                    <a:ext uri="{9D8B030D-6E8A-4147-A177-3AD203B41FA5}">
                      <a16:colId xmlns:a16="http://schemas.microsoft.com/office/drawing/2014/main" val="2285501794"/>
                    </a:ext>
                  </a:extLst>
                </a:gridCol>
                <a:gridCol w="2456846">
                  <a:extLst>
                    <a:ext uri="{9D8B030D-6E8A-4147-A177-3AD203B41FA5}">
                      <a16:colId xmlns:a16="http://schemas.microsoft.com/office/drawing/2014/main" val="293004206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Primers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Forward 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Reverse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720186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C3 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</a:rPr>
                        <a:t>5’-GAC GCC ACT ATG TCC ATC CT-3’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</a:rPr>
                        <a:t>5’-CCA GCA GTT CCA GGT CCT TTG-3’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74953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C5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</a:rPr>
                        <a:t>5’-CAG GGT ACT TTG CCT GCT GA-3’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</a:rPr>
                        <a:t>5’-TGG ATT TTC ATG GTG GGG CA-3’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03458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C3aR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</a:rPr>
                        <a:t>5’-CCA GAC ACA TCC ACA GAT GG-3’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</a:rPr>
                        <a:t>5’-TGT TTG CCA GTG TCT TCC T-3’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951734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C5aR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</a:rPr>
                        <a:t>5’-ACC TTC GAT CCT CGG GGA GC-3’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 dirty="0">
                          <a:effectLst/>
                        </a:rPr>
                        <a:t>5’-GCG TAC ATG TTG AGC AGG AT-3’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333407344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C6CC4F4-D10E-3555-C770-EAF52A4D5B8E}"/>
              </a:ext>
            </a:extLst>
          </p:cNvPr>
          <p:cNvSpPr txBox="1"/>
          <p:nvPr/>
        </p:nvSpPr>
        <p:spPr>
          <a:xfrm>
            <a:off x="3032911" y="3431263"/>
            <a:ext cx="63321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imer sequences of complement pathway components for mRNA quantification analysis. </a:t>
            </a:r>
          </a:p>
        </p:txBody>
      </p:sp>
    </p:spTree>
    <p:extLst>
      <p:ext uri="{BB962C8B-B14F-4D97-AF65-F5344CB8AC3E}">
        <p14:creationId xmlns:p14="http://schemas.microsoft.com/office/powerpoint/2010/main" val="2648693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E2D90B5-83B6-64BA-DEAB-4ADDAFC3F97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30841" y="1696835"/>
          <a:ext cx="3690937" cy="2449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3690611" imgH="2448819" progId="Prism10.Document">
                  <p:embed/>
                </p:oleObj>
              </mc:Choice>
              <mc:Fallback>
                <p:oleObj name="Prism" r:id="rId2" imgW="3690611" imgH="2448819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E2D90B5-83B6-64BA-DEAB-4ADDAFC3F9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30841" y="1696835"/>
                        <a:ext cx="3690937" cy="2449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F7499AE-EC1A-C6E6-4EB2-56EA3A8EF43F}"/>
              </a:ext>
            </a:extLst>
          </p:cNvPr>
          <p:cNvSpPr txBox="1"/>
          <p:nvPr/>
        </p:nvSpPr>
        <p:spPr>
          <a:xfrm>
            <a:off x="195943" y="139959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50BFFE2-0D57-99EA-E23A-0DF1A651B9F2}"/>
              </a:ext>
            </a:extLst>
          </p:cNvPr>
          <p:cNvSpPr txBox="1"/>
          <p:nvPr/>
        </p:nvSpPr>
        <p:spPr>
          <a:xfrm>
            <a:off x="3948561" y="4279014"/>
            <a:ext cx="373002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2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pression of complement C3a in aortic tissue of patients with human AAA was significantly increased compared to controls. **p=0.001; n=5-8/group.</a:t>
            </a:r>
          </a:p>
        </p:txBody>
      </p:sp>
    </p:spTree>
    <p:extLst>
      <p:ext uri="{BB962C8B-B14F-4D97-AF65-F5344CB8AC3E}">
        <p14:creationId xmlns:p14="http://schemas.microsoft.com/office/powerpoint/2010/main" val="13379334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B31B652-7732-7820-28D2-858A3172845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928324" y="1498867"/>
          <a:ext cx="3937000" cy="2444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3936283" imgH="2445446" progId="Prism10.Document">
                  <p:embed/>
                </p:oleObj>
              </mc:Choice>
              <mc:Fallback>
                <p:oleObj name="Prism" r:id="rId2" imgW="3936283" imgH="2445446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AB31B652-7732-7820-28D2-858A317284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28324" y="1498867"/>
                        <a:ext cx="3937000" cy="2444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B0323C9-0F03-9310-FE81-7F4AD60B57F4}"/>
              </a:ext>
            </a:extLst>
          </p:cNvPr>
          <p:cNvSpPr txBox="1"/>
          <p:nvPr/>
        </p:nvSpPr>
        <p:spPr>
          <a:xfrm>
            <a:off x="195943" y="139959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819A799-D9D5-5536-48CF-670A3E2D00D4}"/>
              </a:ext>
            </a:extLst>
          </p:cNvPr>
          <p:cNvSpPr txBox="1"/>
          <p:nvPr/>
        </p:nvSpPr>
        <p:spPr>
          <a:xfrm>
            <a:off x="6509441" y="294237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53AF58F-9FA1-CD00-6098-DACD7F3D59DA}"/>
              </a:ext>
            </a:extLst>
          </p:cNvPr>
          <p:cNvSpPr txBox="1"/>
          <p:nvPr/>
        </p:nvSpPr>
        <p:spPr>
          <a:xfrm>
            <a:off x="4146488" y="4028794"/>
            <a:ext cx="373002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3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ice with Vitamin D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eficient (D) diet exhibited significantly reduced serum 25(OH)D3 levels compared to mice with Vitamin D3 sufficient (S) diet on day 14 post-elastase treatment. n=13-18/group; *p&lt;0.0001 . </a:t>
            </a:r>
          </a:p>
        </p:txBody>
      </p:sp>
    </p:spTree>
    <p:extLst>
      <p:ext uri="{BB962C8B-B14F-4D97-AF65-F5344CB8AC3E}">
        <p14:creationId xmlns:p14="http://schemas.microsoft.com/office/powerpoint/2010/main" val="40093782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70E1A2F-ADF1-3F6A-A84E-84E13B6369A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9F06E246-2785-1F70-D512-0A2132BD523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43006" y="1401655"/>
          <a:ext cx="2339975" cy="2444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2340162" imgH="2445446" progId="Prism10.Document">
                  <p:embed/>
                </p:oleObj>
              </mc:Choice>
              <mc:Fallback>
                <p:oleObj name="Prism" r:id="rId2" imgW="2340162" imgH="2445446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9F06E246-2785-1F70-D512-0A2132BD52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43006" y="1401655"/>
                        <a:ext cx="2339975" cy="2444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9F52F35-99AE-081A-AC18-74501B9A80C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217752" y="1415358"/>
          <a:ext cx="2428875" cy="2444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4" imgW="2428755" imgH="2445446" progId="Prism10.Document">
                  <p:embed/>
                </p:oleObj>
              </mc:Choice>
              <mc:Fallback>
                <p:oleObj name="Prism" r:id="rId4" imgW="2428755" imgH="2445446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9F52F35-99AE-081A-AC18-74501B9A80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17752" y="1415358"/>
                        <a:ext cx="2428875" cy="2444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076A5DD-2825-5A7A-1444-6BAE69E0D1E2}"/>
              </a:ext>
            </a:extLst>
          </p:cNvPr>
          <p:cNvSpPr txBox="1"/>
          <p:nvPr/>
        </p:nvSpPr>
        <p:spPr>
          <a:xfrm>
            <a:off x="3401831" y="152780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6806696-F0B8-ADF5-C4A9-6F5944D9C94F}"/>
              </a:ext>
            </a:extLst>
          </p:cNvPr>
          <p:cNvSpPr txBox="1"/>
          <p:nvPr/>
        </p:nvSpPr>
        <p:spPr>
          <a:xfrm>
            <a:off x="5203942" y="151527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A28D7B7-143B-18A6-5F65-746852DB85C3}"/>
              </a:ext>
            </a:extLst>
          </p:cNvPr>
          <p:cNvSpPr txBox="1"/>
          <p:nvPr/>
        </p:nvSpPr>
        <p:spPr>
          <a:xfrm>
            <a:off x="195943" y="139959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0363BA21-B7DA-C56F-5A22-8B10A1D2992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53200" y="1401763"/>
          <a:ext cx="2352675" cy="2449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6" imgW="2352661" imgH="2448819" progId="Prism10.Document">
                  <p:embed/>
                </p:oleObj>
              </mc:Choice>
              <mc:Fallback>
                <p:oleObj name="Prism" r:id="rId6" imgW="2352661" imgH="2448819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0363BA21-B7DA-C56F-5A22-8B10A1D299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553200" y="1401763"/>
                        <a:ext cx="2352675" cy="2449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78B89C55-48AB-9C7C-EFA0-FB68F90EF1CF}"/>
              </a:ext>
            </a:extLst>
          </p:cNvPr>
          <p:cNvSpPr txBox="1"/>
          <p:nvPr/>
        </p:nvSpPr>
        <p:spPr>
          <a:xfrm>
            <a:off x="6793257" y="149972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BDBF84B-B8D1-CC81-FBD5-8CA84B70B904}"/>
              </a:ext>
            </a:extLst>
          </p:cNvPr>
          <p:cNvSpPr txBox="1"/>
          <p:nvPr/>
        </p:nvSpPr>
        <p:spPr>
          <a:xfrm>
            <a:off x="3413156" y="3992578"/>
            <a:ext cx="553166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4. A-C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tamin D3 deficiency did not alter the mRNA expression of C3aR, C5 and C5aR compared to vitamin D3 sufficient mice in aortic tissue of elastase-treated WT mice on day 14. n=10/group; ns, not significant. 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9BE6C21-4BD1-465F-49A6-7EAF455C6209}"/>
              </a:ext>
            </a:extLst>
          </p:cNvPr>
          <p:cNvCxnSpPr/>
          <p:nvPr/>
        </p:nvCxnSpPr>
        <p:spPr>
          <a:xfrm>
            <a:off x="4336610" y="2263366"/>
            <a:ext cx="5160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16A46536-E837-F2FC-30DC-682F1ECC7C60}"/>
              </a:ext>
            </a:extLst>
          </p:cNvPr>
          <p:cNvCxnSpPr/>
          <p:nvPr/>
        </p:nvCxnSpPr>
        <p:spPr>
          <a:xfrm>
            <a:off x="5964725" y="2515354"/>
            <a:ext cx="5160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DFFD37D-5006-7D23-2285-3AC487FA4EED}"/>
              </a:ext>
            </a:extLst>
          </p:cNvPr>
          <p:cNvCxnSpPr/>
          <p:nvPr/>
        </p:nvCxnSpPr>
        <p:spPr>
          <a:xfrm>
            <a:off x="7603402" y="1655275"/>
            <a:ext cx="5160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5FFFCC0A-2858-D99A-2CCE-5B98072CFEC5}"/>
              </a:ext>
            </a:extLst>
          </p:cNvPr>
          <p:cNvSpPr txBox="1"/>
          <p:nvPr/>
        </p:nvSpPr>
        <p:spPr>
          <a:xfrm>
            <a:off x="4427145" y="2027976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1089A6A-3FDA-B025-986D-30EA66231E5B}"/>
              </a:ext>
            </a:extLst>
          </p:cNvPr>
          <p:cNvSpPr txBox="1"/>
          <p:nvPr/>
        </p:nvSpPr>
        <p:spPr>
          <a:xfrm>
            <a:off x="6064313" y="2261857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53E1502-E8E0-4106-D569-ECB79342FAD8}"/>
              </a:ext>
            </a:extLst>
          </p:cNvPr>
          <p:cNvSpPr txBox="1"/>
          <p:nvPr/>
        </p:nvSpPr>
        <p:spPr>
          <a:xfrm>
            <a:off x="7693937" y="1419885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34546452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4482BAC-BC10-5216-6355-B486F5FA05B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767720" y="1514475"/>
          <a:ext cx="3897313" cy="2663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3896668" imgH="2663699" progId="Prism10.Document">
                  <p:embed/>
                </p:oleObj>
              </mc:Choice>
              <mc:Fallback>
                <p:oleObj name="Prism" r:id="rId2" imgW="3896668" imgH="2663699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4482BAC-BC10-5216-6355-B486F5FA05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767720" y="1514475"/>
                        <a:ext cx="3897313" cy="2663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1B92AA98-414F-CC29-E650-B2E27751AB8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4287" r="42408"/>
          <a:stretch>
            <a:fillRect/>
          </a:stretch>
        </p:blipFill>
        <p:spPr>
          <a:xfrm flipH="1">
            <a:off x="2408173" y="2471055"/>
            <a:ext cx="2578460" cy="482427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8E835EC9-F646-1F46-F1C9-26C5FEE12B87}"/>
              </a:ext>
            </a:extLst>
          </p:cNvPr>
          <p:cNvCxnSpPr>
            <a:cxnSpLocks/>
          </p:cNvCxnSpPr>
          <p:nvPr/>
        </p:nvCxnSpPr>
        <p:spPr>
          <a:xfrm flipV="1">
            <a:off x="2531977" y="2410613"/>
            <a:ext cx="1063342" cy="829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F3CE2667-8B00-DFEB-144E-06A53707C33C}"/>
              </a:ext>
            </a:extLst>
          </p:cNvPr>
          <p:cNvSpPr txBox="1"/>
          <p:nvPr/>
        </p:nvSpPr>
        <p:spPr>
          <a:xfrm>
            <a:off x="2489703" y="2146864"/>
            <a:ext cx="12305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lastase+BAPN</a:t>
            </a:r>
            <a:endParaRPr kumimoji="0" 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465E7A1-0FA9-FAB0-59CE-9349F1A84A9C}"/>
              </a:ext>
            </a:extLst>
          </p:cNvPr>
          <p:cNvCxnSpPr>
            <a:cxnSpLocks/>
          </p:cNvCxnSpPr>
          <p:nvPr/>
        </p:nvCxnSpPr>
        <p:spPr>
          <a:xfrm>
            <a:off x="3780729" y="2409849"/>
            <a:ext cx="1099089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E9341D30-A686-FC3F-FC0E-31DD7EC85D60}"/>
              </a:ext>
            </a:extLst>
          </p:cNvPr>
          <p:cNvSpPr txBox="1"/>
          <p:nvPr/>
        </p:nvSpPr>
        <p:spPr>
          <a:xfrm>
            <a:off x="4943501" y="2437442"/>
            <a:ext cx="9140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-MMP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0A118A-79EE-5E58-D3FE-BCDCCF5FCEED}"/>
              </a:ext>
            </a:extLst>
          </p:cNvPr>
          <p:cNvSpPr txBox="1"/>
          <p:nvPr/>
        </p:nvSpPr>
        <p:spPr>
          <a:xfrm>
            <a:off x="4957782" y="2618600"/>
            <a:ext cx="7006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MP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2431CDE-BDED-4269-BD61-B83ED816CE5B}"/>
              </a:ext>
            </a:extLst>
          </p:cNvPr>
          <p:cNvSpPr txBox="1"/>
          <p:nvPr/>
        </p:nvSpPr>
        <p:spPr>
          <a:xfrm>
            <a:off x="3791894" y="2009556"/>
            <a:ext cx="123056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lastase+BAPN</a:t>
            </a:r>
            <a:endParaRPr kumimoji="0" 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+C3aRA</a:t>
            </a:r>
            <a:endParaRPr kumimoji="0" 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5AB3EAB-E058-0D7F-0CD6-2ED8E3EA640E}"/>
              </a:ext>
            </a:extLst>
          </p:cNvPr>
          <p:cNvSpPr txBox="1"/>
          <p:nvPr/>
        </p:nvSpPr>
        <p:spPr>
          <a:xfrm>
            <a:off x="195943" y="139959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7B0678A-6945-B262-8036-B3779B62DC14}"/>
              </a:ext>
            </a:extLst>
          </p:cNvPr>
          <p:cNvSpPr txBox="1"/>
          <p:nvPr/>
        </p:nvSpPr>
        <p:spPr>
          <a:xfrm>
            <a:off x="2435377" y="4218915"/>
            <a:ext cx="648228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5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latin zymography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quantification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of pro- and active MMP2 expressions in aortic tissue demonstrated a significant decrease in MMP2 activity on day 28 in C3aRA-treated mice compared to untreated mice exposed to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lastase+BAP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n=4/group; **p=0.001; ***p=0.0009.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66F5531-0DF8-C073-AF7D-48A0A77042D6}"/>
              </a:ext>
            </a:extLst>
          </p:cNvPr>
          <p:cNvSpPr txBox="1"/>
          <p:nvPr/>
        </p:nvSpPr>
        <p:spPr>
          <a:xfrm>
            <a:off x="2236204" y="17201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E0B489-4CA7-DE07-B7AB-C57E19F1A9F6}"/>
              </a:ext>
            </a:extLst>
          </p:cNvPr>
          <p:cNvSpPr txBox="1"/>
          <p:nvPr/>
        </p:nvSpPr>
        <p:spPr>
          <a:xfrm>
            <a:off x="5638801" y="168243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0694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4</Words>
  <Application>Microsoft Office PowerPoint</Application>
  <PresentationFormat>Widescreen</PresentationFormat>
  <Paragraphs>39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Times New Roman</vt:lpstr>
      <vt:lpstr>Office Theme</vt:lpstr>
      <vt:lpstr>Prism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arma,Ashish Kumar</dc:creator>
  <cp:lastModifiedBy>Sharma,Ashish Kumar</cp:lastModifiedBy>
  <cp:revision>1</cp:revision>
  <dcterms:created xsi:type="dcterms:W3CDTF">2026-06-05T15:59:05Z</dcterms:created>
  <dcterms:modified xsi:type="dcterms:W3CDTF">2026-06-05T15:59:27Z</dcterms:modified>
</cp:coreProperties>
</file>